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5" d="100"/>
          <a:sy n="65" d="100"/>
        </p:scale>
        <p:origin x="3318" y="2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580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8111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85853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23790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1020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62888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88538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6132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91021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88538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0503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6726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DA674D04-86D6-502A-6CE8-7C31DF1E2C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53725" y="1085993"/>
            <a:ext cx="3950550" cy="5517358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1CC5581-E195-5DBB-6C08-DE37DAD873A2}"/>
              </a:ext>
            </a:extLst>
          </p:cNvPr>
          <p:cNvSpPr txBox="1"/>
          <p:nvPr/>
        </p:nvSpPr>
        <p:spPr>
          <a:xfrm>
            <a:off x="549000" y="7065408"/>
            <a:ext cx="576000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.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ss morphology of angiotensin II (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gI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ype 1 receptor (AGTR1)-overexpressing bladder cancer cell xenografts under losartan (LOS) treatment. (A) Photographs of the harvested tumors from all mice transplanted with AGTR1-overexpressing T24 tumors without LOS (n = 8) and from four of six LOS-treated mice that did not develop cystic change. Scale bar: 5 mm. (B) Representative photograph of a LOS-treated mouse showing a large cystic change immediately after euthanasia (left panel). The syringe containing serous fluid aspirated from the cystic lesion is also shown. The corresponding image displaying a large cyst wall involving the peritoneum and a solid tumor is presented in the right panel. Scale bar: 5 mm; arrow indicates solid tumor.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470786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141</Words>
  <Application>Microsoft Office PowerPoint</Application>
  <PresentationFormat>A4 210 x 297 mm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神沼　修</dc:creator>
  <cp:lastModifiedBy>神沼　修</cp:lastModifiedBy>
  <cp:revision>6</cp:revision>
  <dcterms:created xsi:type="dcterms:W3CDTF">2025-07-04T02:55:30Z</dcterms:created>
  <dcterms:modified xsi:type="dcterms:W3CDTF">2025-10-22T03:50:55Z</dcterms:modified>
</cp:coreProperties>
</file>